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6" r:id="rId2"/>
    <p:sldId id="264" r:id="rId3"/>
  </p:sldIdLst>
  <p:sldSz cx="9144000" cy="5143500" type="screen16x9"/>
  <p:notesSz cx="6858000" cy="9144000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D0D84A80-CE1A-4ADD-A5D6-71699BD26863}">
          <p14:sldIdLst>
            <p14:sldId id="266"/>
          </p14:sldIdLst>
        </p14:section>
        <p14:section name="Untitled Section" id="{A2CCFE4C-EF63-491B-AD2E-AD524F6B4059}">
          <p14:sldIdLst>
            <p14:sldId id="264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906" y="72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841772"/>
            <a:ext cx="6858000" cy="17907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2701528"/>
            <a:ext cx="6858000" cy="124182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C8453B-90C4-A5EB-0B81-753C10CA0D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F955DC-C7C1-4376-9534-E92E57EBDDDB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57893A-0A44-7816-5EAD-6D33A8B5DC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88B4FE-6063-6855-9B98-8AAA0258A4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B93433F-34DA-4C69-92AD-F7FC1E3C2F96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2839957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23351E-E0D2-01B5-78B6-5B60527CE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9BAF80-B914-4C1A-BE4E-3B42C85AEC71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D426FF-254F-7656-FD21-6950B40D89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BA51D4-C21A-D49D-7997-AE8E4EB0DE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CA40401-FB40-434F-806C-46E51DAE8CF1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04721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273844"/>
            <a:ext cx="1971675" cy="43588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273844"/>
            <a:ext cx="5800725" cy="435887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EEC6A0-5E7A-346F-EDD6-92C02A651F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18C23E-DF59-48E9-BEE9-32AC4128E6B7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E6EB7D-C592-A7B5-7DC4-0D51D5DE7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4F9589-8F4B-880D-1DAA-D8EDC9056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CAF9A0D-A95F-4A2B-89C4-0C13CF3957EB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169432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211EDE-7073-2202-9155-2CDB569AC3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6496D4-D55C-4279-9A96-FF9BBB5260DE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4D387E-6EAE-95EC-9B0D-D48EA68D5C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DB3C6F-B9E3-D9B9-6F11-8230479226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CDDE7DE-AD13-4FAA-8224-CED41ED18AA8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247312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282304"/>
            <a:ext cx="7886700" cy="213955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442098"/>
            <a:ext cx="7886700" cy="112514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51D4B2-51D9-F669-DC71-933217BD21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688E2F-CA85-4EBF-A7CE-ED2F0151CFE6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A302B2-921D-5B8C-02DF-2393AA7AF3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5B5777-2A9A-3D46-7C1F-51CA849BE2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6154E6B-3393-42B2-A519-A5E57359B0C5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31839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1D1BB1AF-A5F6-AB98-9FE0-5D8056ABBB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57D44B-DCFE-4542-8037-E2F89F857E4B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D63195A3-6C94-BECF-ADFA-F600E7BD4F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9E096395-C0FE-B7CC-C5B7-3E39643358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0CD20EF-1CA4-45F0-B212-CF6C7EBC03A7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31465330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273844"/>
            <a:ext cx="7886700" cy="99417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260872"/>
            <a:ext cx="3868340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1878806"/>
            <a:ext cx="3868340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260872"/>
            <a:ext cx="3887391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1878806"/>
            <a:ext cx="3887391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7884EBDA-9F96-65CB-8C91-EAB789826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F33588-C768-42F3-B320-CA9D66169FC6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C6673F07-4BF2-539B-F064-3C01C814BE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2595270C-309B-6A76-E0A2-69D7B6144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EBC293B-7CA6-487F-B4A5-E2E65FFBB48E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37475109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5388E6E5-2972-90D8-0D59-B553E3A16C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5B427F-F011-4806-ABDD-BCB025D97FB6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1FD084FB-A36D-4FBB-3AE0-C91CA0E850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566E01CD-3B7F-AF05-4489-98E6F9DDA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E2C52B1-5DEE-4F53-B88B-35B8519700EB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1685632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D808274A-3A5D-4BDA-9028-1CEC991E8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14E764-C10B-4DAC-98D8-A573F5949B81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C0D4B752-7E7C-033E-E1AB-DF2A5B036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BFB4D461-81FB-2237-CB38-7FAED3E18C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507B75A-CC9D-4F89-BC20-8F2CF2E7E54D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23343226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740569"/>
            <a:ext cx="4629150" cy="365521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4946A807-79E0-C924-F632-B0FC9DDB4F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57B315-1BC6-494C-BFE9-0E64193A442B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3E3BFBEA-C487-3C5D-4A81-0FD606912A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D071BBDF-D2BE-E117-614B-35A7CEB081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39EC089-A1E2-4348-A6F0-62BCC7C13DAB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1113641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740569"/>
            <a:ext cx="4629150" cy="3655219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92AB9644-9619-DE4D-A625-5F1CA37E37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172EA2-86FE-4500-9270-7D9CAFD90180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6AD111D1-10A9-EB92-9A2D-994E148CF4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C20702F5-837A-94B3-70F1-3B0DBA656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AE934D1-4156-4698-81F1-1C3A6887CEC5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272893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891C6471-FC74-6D79-2C87-52AC88FDD7EE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628650" y="274638"/>
            <a:ext cx="7886700" cy="993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ar-YE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D8CC31AA-3859-B8A0-D401-40D861F2336B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628650" y="1370013"/>
            <a:ext cx="7886700" cy="3262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ar-YE"/>
              <a:t>Click to edit Master text styles</a:t>
            </a:r>
          </a:p>
          <a:p>
            <a:pPr lvl="1"/>
            <a:r>
              <a:rPr lang="en-US" altLang="ar-YE"/>
              <a:t>Second level</a:t>
            </a:r>
          </a:p>
          <a:p>
            <a:pPr lvl="2"/>
            <a:r>
              <a:rPr lang="en-US" altLang="ar-YE"/>
              <a:t>Third level</a:t>
            </a:r>
          </a:p>
          <a:p>
            <a:pPr lvl="3"/>
            <a:r>
              <a:rPr lang="en-US" altLang="ar-YE"/>
              <a:t>Fourth level</a:t>
            </a:r>
          </a:p>
          <a:p>
            <a:pPr lvl="4"/>
            <a:r>
              <a:rPr lang="en-US" altLang="ar-YE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B8E075-2ED6-59B5-B9E8-D858F6E7C3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4767263"/>
            <a:ext cx="2057400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82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82514F9A-75F6-4D34-B512-92A57F93648C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454FD9-1F2E-5D95-FFFC-341D9B97B6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4767263"/>
            <a:ext cx="3086100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82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E5039F-C134-F82E-C2F4-3E2B8CF6B5D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4767263"/>
            <a:ext cx="2057400" cy="274637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900">
                <a:solidFill>
                  <a:srgbClr val="767676"/>
                </a:solidFill>
              </a:defRPr>
            </a:lvl1pPr>
          </a:lstStyle>
          <a:p>
            <a:fld id="{B232C4A3-EF3D-4E57-A5A9-C8A551E1D9FA}" type="slidenum">
              <a:rPr lang="ar-YE" altLang="ar-YE"/>
              <a:pPr/>
              <a:t>‹#›</a:t>
            </a:fld>
            <a:endParaRPr lang="ar-YE" altLang="ar-Y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2pPr>
      <a:lvl3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3pPr>
      <a:lvl4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4pPr>
      <a:lvl5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5pPr>
      <a:lvl6pPr marL="4572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6pPr>
      <a:lvl7pPr marL="9144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7pPr>
      <a:lvl8pPr marL="13716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8pPr>
      <a:lvl9pPr marL="18288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9pPr>
    </p:titleStyle>
    <p:bodyStyle>
      <a:lvl1pPr marL="171450" indent="-171450" algn="r" defTabSz="685800" rtl="1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B1C2F4-D018-9CC1-5E4E-655929A618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 algn="l" rtl="0">
              <a:buNone/>
            </a:pPr>
            <a:r>
              <a:rPr lang="nl-NL" sz="1800" b="1" dirty="0">
                <a:cs typeface="+mj-cs"/>
              </a:rPr>
              <a:t>Figure S2.1. </a:t>
            </a:r>
            <a:r>
              <a:rPr lang="nl-NL" sz="1800" dirty="0">
                <a:cs typeface="+mj-cs"/>
              </a:rPr>
              <a:t>Six-factor confirmatory factor analysis (CFA) model for the 42-item JCI patient-centered standards instrument. Standardised estimates are displayed. Model fit: </a:t>
            </a:r>
            <a:r>
              <a:rPr lang="el-GR" sz="1800" dirty="0">
                <a:cs typeface="+mj-cs"/>
              </a:rPr>
              <a:t>χ²/</a:t>
            </a:r>
            <a:r>
              <a:rPr lang="nl-NL" sz="1800" dirty="0">
                <a:cs typeface="+mj-cs"/>
              </a:rPr>
              <a:t>df = 2.514; CFI = 0.943; TLI = 0.935; RMSEA = 0.054 (90% CI: 0.052, 0.056). All factor loadings are significant at p &lt; 0.001. CFA, confirmatory factor analysis; CFI, comparative fit index; CI, confidence interval; JCI, Joint Commission International; RMSEA, root mean square error of approximation; TLI, Tucker–Lewis index.</a:t>
            </a:r>
            <a:endParaRPr lang="ar-YE" sz="1800" dirty="0">
              <a:cs typeface="+mj-cs"/>
            </a:endParaRPr>
          </a:p>
        </p:txBody>
      </p:sp>
    </p:spTree>
    <p:extLst>
      <p:ext uri="{BB962C8B-B14F-4D97-AF65-F5344CB8AC3E}">
        <p14:creationId xmlns:p14="http://schemas.microsoft.com/office/powerpoint/2010/main" val="36356491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9E51FD99-9D9B-8C84-C9F0-504E3C2EA6A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270" y="29915"/>
            <a:ext cx="8747393" cy="53109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1</TotalTime>
  <Words>102</Words>
  <Application>Microsoft Office PowerPoint</Application>
  <PresentationFormat>On-screen Show (16:9)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عرض تقديمي في PowerPoint</dc:title>
  <dc:creator>Haitham Jowah</dc:creator>
  <cp:lastModifiedBy>Haitham Jowah</cp:lastModifiedBy>
  <cp:revision>8</cp:revision>
  <dcterms:created xsi:type="dcterms:W3CDTF">2026-05-06T20:22:58Z</dcterms:created>
  <dcterms:modified xsi:type="dcterms:W3CDTF">2026-05-07T01:41:31Z</dcterms:modified>
</cp:coreProperties>
</file>